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61" autoAdjust="0"/>
    <p:restoredTop sz="94660"/>
  </p:normalViewPr>
  <p:slideViewPr>
    <p:cSldViewPr snapToGrid="0">
      <p:cViewPr varScale="1">
        <p:scale>
          <a:sx n="32" d="100"/>
          <a:sy n="32" d="100"/>
        </p:scale>
        <p:origin x="186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AE7831-9EB2-459B-A3DA-213DF5D5A402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E5271B-317A-48A8-A44E-E04A32F760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5876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Additional</a:t>
            </a:r>
            <a:r>
              <a:rPr lang="en-US" b="1" baseline="0" dirty="0" smtClean="0"/>
              <a:t> File 1</a:t>
            </a:r>
            <a:r>
              <a:rPr lang="en-US" dirty="0" smtClean="0"/>
              <a:t>. </a:t>
            </a:r>
            <a:r>
              <a:rPr lang="en-US" dirty="0" err="1" smtClean="0"/>
              <a:t>HoxD</a:t>
            </a:r>
            <a:r>
              <a:rPr lang="en-US" dirty="0" smtClean="0"/>
              <a:t> expression in the pelvic fin of the little skate during early</a:t>
            </a:r>
            <a:r>
              <a:rPr lang="en-US" baseline="0" dirty="0" smtClean="0"/>
              <a:t> to late development (</a:t>
            </a:r>
            <a:r>
              <a:rPr lang="en-US" b="1" baseline="0" dirty="0" smtClean="0"/>
              <a:t>A-H</a:t>
            </a:r>
            <a:r>
              <a:rPr lang="en-US" baseline="0" dirty="0" smtClean="0"/>
              <a:t>). Note that both </a:t>
            </a:r>
            <a:r>
              <a:rPr lang="en-US" i="1" baseline="0" dirty="0" smtClean="0"/>
              <a:t>HoxD12</a:t>
            </a:r>
            <a:r>
              <a:rPr lang="en-US" baseline="0" dirty="0" smtClean="0"/>
              <a:t> (</a:t>
            </a:r>
            <a:r>
              <a:rPr lang="en-US" b="1" baseline="0" dirty="0" smtClean="0"/>
              <a:t>A-B</a:t>
            </a:r>
            <a:r>
              <a:rPr lang="en-US" baseline="0" dirty="0" smtClean="0"/>
              <a:t>) and </a:t>
            </a:r>
            <a:r>
              <a:rPr lang="en-US" i="1" baseline="0" dirty="0" smtClean="0"/>
              <a:t>HoxD13</a:t>
            </a:r>
            <a:r>
              <a:rPr lang="en-US" baseline="0" dirty="0" smtClean="0"/>
              <a:t> (</a:t>
            </a:r>
            <a:r>
              <a:rPr lang="en-US" b="1" baseline="0" dirty="0" smtClean="0"/>
              <a:t>C-H</a:t>
            </a:r>
            <a:r>
              <a:rPr lang="en-US" baseline="0" dirty="0" smtClean="0"/>
              <a:t>) are expressed exclusively in the claspers, and show no expression in the female pelvic fin. </a:t>
            </a:r>
            <a:r>
              <a:rPr lang="en-US" i="1" baseline="0" dirty="0" smtClean="0"/>
              <a:t>HoxD12</a:t>
            </a:r>
            <a:r>
              <a:rPr lang="en-US" baseline="0" dirty="0" smtClean="0"/>
              <a:t> is expressed in the posterior pectoral fin (I), </a:t>
            </a:r>
            <a:r>
              <a:rPr lang="en-US" i="1" baseline="0" dirty="0" smtClean="0"/>
              <a:t>HoxD13</a:t>
            </a:r>
            <a:r>
              <a:rPr lang="en-US" baseline="0" dirty="0" smtClean="0"/>
              <a:t> shows no expression at stage 30 in the pectoral fin (</a:t>
            </a:r>
            <a:r>
              <a:rPr lang="en-US" b="1" baseline="0" dirty="0" smtClean="0"/>
              <a:t>J</a:t>
            </a:r>
            <a:r>
              <a:rPr lang="en-US" baseline="0" dirty="0" smtClean="0"/>
              <a:t>). </a:t>
            </a:r>
            <a:r>
              <a:rPr lang="en-US" b="0" baseline="0" dirty="0" smtClean="0"/>
              <a:t>Similarly, the posterior </a:t>
            </a:r>
            <a:r>
              <a:rPr lang="en-US" b="0" baseline="0" dirty="0" err="1" smtClean="0"/>
              <a:t>HoxA</a:t>
            </a:r>
            <a:r>
              <a:rPr lang="en-US" b="0" baseline="0" dirty="0" smtClean="0"/>
              <a:t> genes are not expressed in the posterior pectoral fin, indicating a unique </a:t>
            </a:r>
            <a:r>
              <a:rPr lang="en-US" b="0" baseline="0" dirty="0" err="1" smtClean="0"/>
              <a:t>Hox</a:t>
            </a:r>
            <a:r>
              <a:rPr lang="en-US" b="0" baseline="0" dirty="0" smtClean="0"/>
              <a:t> code that specifies specific morphologies during development. </a:t>
            </a:r>
            <a:endParaRPr lang="en-US" b="0" dirty="0" smtClean="0"/>
          </a:p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9DD456-4FED-49CF-B105-A00D5C335D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4873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779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30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23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519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45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313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50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516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863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68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948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5D3F9-8152-4D21-9E64-A20F502582A8}" type="datetimeFigureOut">
              <a:rPr lang="en-US" smtClean="0"/>
              <a:t>7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10523-5F24-4857-86F2-17A732A40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18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58" t="24225" r="31276" b="19061"/>
          <a:stretch/>
        </p:blipFill>
        <p:spPr>
          <a:xfrm>
            <a:off x="2375519" y="3067725"/>
            <a:ext cx="593192" cy="45073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35" t="14460" r="29191" b="23005"/>
          <a:stretch/>
        </p:blipFill>
        <p:spPr>
          <a:xfrm>
            <a:off x="2356834" y="3690222"/>
            <a:ext cx="617909" cy="47591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141756" y="3097597"/>
            <a:ext cx="6664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i="1" dirty="0"/>
              <a:t>HoxD12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75513" y="3811271"/>
            <a:ext cx="59896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i="1" dirty="0"/>
              <a:t>HoxD13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97" t="18779" r="17372" b="11925"/>
          <a:stretch/>
        </p:blipFill>
        <p:spPr>
          <a:xfrm>
            <a:off x="2968711" y="3067725"/>
            <a:ext cx="566025" cy="450733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40" t="18592" r="20430" b="8544"/>
          <a:stretch/>
        </p:blipFill>
        <p:spPr>
          <a:xfrm>
            <a:off x="2974742" y="3689879"/>
            <a:ext cx="577873" cy="47625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18280" y="3704614"/>
            <a:ext cx="621567" cy="461524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26559" y="3067725"/>
            <a:ext cx="826268" cy="450733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254"/>
          <a:stretch/>
        </p:blipFill>
        <p:spPr>
          <a:xfrm>
            <a:off x="4923756" y="3704614"/>
            <a:ext cx="844582" cy="461524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07" t="35820" r="5867" b="10846"/>
          <a:stretch/>
        </p:blipFill>
        <p:spPr>
          <a:xfrm>
            <a:off x="5752828" y="3067725"/>
            <a:ext cx="786618" cy="450733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5" t="58878" r="27573" b="7897"/>
          <a:stretch/>
        </p:blipFill>
        <p:spPr>
          <a:xfrm>
            <a:off x="5768338" y="3704615"/>
            <a:ext cx="771108" cy="461524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2674659" y="2585780"/>
            <a:ext cx="66148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Stage 3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900728" y="2590435"/>
            <a:ext cx="84766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Stage 31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422949" y="2576121"/>
            <a:ext cx="104086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Stage 32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412090" y="2888460"/>
            <a:ext cx="468297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Male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954227" y="2881950"/>
            <a:ext cx="537485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Female</a:t>
            </a:r>
            <a:endParaRPr lang="en-US" sz="675" dirty="0"/>
          </a:p>
        </p:txBody>
      </p:sp>
      <p:sp>
        <p:nvSpPr>
          <p:cNvPr id="44" name="TextBox 43"/>
          <p:cNvSpPr txBox="1"/>
          <p:nvPr/>
        </p:nvSpPr>
        <p:spPr>
          <a:xfrm>
            <a:off x="3700545" y="2895452"/>
            <a:ext cx="430480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Male</a:t>
            </a:r>
            <a:endParaRPr lang="en-US" sz="675" dirty="0"/>
          </a:p>
        </p:txBody>
      </p:sp>
      <p:sp>
        <p:nvSpPr>
          <p:cNvPr id="45" name="TextBox 44"/>
          <p:cNvSpPr txBox="1"/>
          <p:nvPr/>
        </p:nvSpPr>
        <p:spPr>
          <a:xfrm>
            <a:off x="4239848" y="2895037"/>
            <a:ext cx="52090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Female</a:t>
            </a:r>
            <a:endParaRPr lang="en-US" sz="675" dirty="0"/>
          </a:p>
        </p:txBody>
      </p:sp>
      <p:sp>
        <p:nvSpPr>
          <p:cNvPr id="46" name="TextBox 45"/>
          <p:cNvSpPr txBox="1"/>
          <p:nvPr/>
        </p:nvSpPr>
        <p:spPr>
          <a:xfrm>
            <a:off x="5094120" y="2888460"/>
            <a:ext cx="420321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Male</a:t>
            </a:r>
            <a:endParaRPr lang="en-US" sz="675" dirty="0"/>
          </a:p>
        </p:txBody>
      </p:sp>
      <p:sp>
        <p:nvSpPr>
          <p:cNvPr id="47" name="TextBox 46"/>
          <p:cNvSpPr txBox="1"/>
          <p:nvPr/>
        </p:nvSpPr>
        <p:spPr>
          <a:xfrm>
            <a:off x="5840434" y="2896079"/>
            <a:ext cx="495546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Female</a:t>
            </a:r>
            <a:endParaRPr lang="en-US" sz="675" dirty="0"/>
          </a:p>
        </p:txBody>
      </p:sp>
      <p:sp>
        <p:nvSpPr>
          <p:cNvPr id="49" name="TextBox 48"/>
          <p:cNvSpPr txBox="1"/>
          <p:nvPr/>
        </p:nvSpPr>
        <p:spPr>
          <a:xfrm>
            <a:off x="2349395" y="3000490"/>
            <a:ext cx="10696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879161" y="3016263"/>
            <a:ext cx="16194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50113" y="2592974"/>
            <a:ext cx="63806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Stage 29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51925" y="2577920"/>
            <a:ext cx="63178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Stage 28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93547" y="2592974"/>
            <a:ext cx="64496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Stage 27</a:t>
            </a:r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92" t="18714" r="22355" b="5630"/>
          <a:stretch/>
        </p:blipFill>
        <p:spPr>
          <a:xfrm>
            <a:off x="1204101" y="3689879"/>
            <a:ext cx="484680" cy="479172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04" t="16106" r="20997" b="6499"/>
          <a:stretch/>
        </p:blipFill>
        <p:spPr>
          <a:xfrm>
            <a:off x="1756517" y="3689879"/>
            <a:ext cx="537456" cy="47625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9847" y="3704615"/>
            <a:ext cx="621048" cy="46152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48" t="12395" r="30212" b="10176"/>
          <a:stretch/>
        </p:blipFill>
        <p:spPr>
          <a:xfrm>
            <a:off x="693180" y="3558006"/>
            <a:ext cx="445697" cy="608132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863976" y="2858404"/>
            <a:ext cx="1470935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/>
              <a:t>Indeterminate sex</a:t>
            </a:r>
          </a:p>
        </p:txBody>
      </p:sp>
      <p:sp>
        <p:nvSpPr>
          <p:cNvPr id="68" name="TextBox 67"/>
          <p:cNvSpPr txBox="1"/>
          <p:nvPr/>
        </p:nvSpPr>
        <p:spPr>
          <a:xfrm rot="16200000">
            <a:off x="888730" y="5923784"/>
            <a:ext cx="7106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Stage 30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069147" y="4988088"/>
            <a:ext cx="74536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/>
              <a:t>HoxD12</a:t>
            </a:r>
            <a:endParaRPr lang="en-US" sz="1350" i="1" dirty="0"/>
          </a:p>
        </p:txBody>
      </p:sp>
      <p:sp>
        <p:nvSpPr>
          <p:cNvPr id="80" name="TextBox 79"/>
          <p:cNvSpPr txBox="1"/>
          <p:nvPr/>
        </p:nvSpPr>
        <p:spPr>
          <a:xfrm>
            <a:off x="4143408" y="4988088"/>
            <a:ext cx="74536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/>
              <a:t>HoxD13</a:t>
            </a:r>
            <a:endParaRPr lang="en-US" sz="1350" i="1" dirty="0"/>
          </a:p>
        </p:txBody>
      </p:sp>
      <p:grpSp>
        <p:nvGrpSpPr>
          <p:cNvPr id="6" name="Group 5"/>
          <p:cNvGrpSpPr/>
          <p:nvPr/>
        </p:nvGrpSpPr>
        <p:grpSpPr>
          <a:xfrm>
            <a:off x="1371019" y="5246592"/>
            <a:ext cx="2217835" cy="1601919"/>
            <a:chOff x="2101959" y="4898303"/>
            <a:chExt cx="1395702" cy="1091361"/>
          </a:xfrm>
        </p:grpSpPr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64" t="-1" b="931"/>
            <a:stretch/>
          </p:blipFill>
          <p:spPr>
            <a:xfrm>
              <a:off x="2137143" y="4922414"/>
              <a:ext cx="1193599" cy="1010553"/>
            </a:xfrm>
            <a:prstGeom prst="rect">
              <a:avLst/>
            </a:prstGeom>
          </p:spPr>
        </p:pic>
        <p:sp>
          <p:nvSpPr>
            <p:cNvPr id="69" name="TextBox 68"/>
            <p:cNvSpPr txBox="1"/>
            <p:nvPr/>
          </p:nvSpPr>
          <p:spPr>
            <a:xfrm>
              <a:off x="2101959" y="4898303"/>
              <a:ext cx="159989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25" b="1" dirty="0" smtClean="0"/>
                <a:t>I</a:t>
              </a:r>
              <a:endParaRPr lang="en-US" sz="825" b="1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2891268" y="5728054"/>
              <a:ext cx="6063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 smtClean="0"/>
                <a:t>Dorsal</a:t>
              </a:r>
              <a:endParaRPr lang="en-US" sz="1100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659981" y="3548297"/>
            <a:ext cx="277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C</a:t>
            </a:r>
            <a:endParaRPr lang="en-US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135417" y="3635891"/>
            <a:ext cx="277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</a:t>
            </a:r>
            <a:endParaRPr lang="en-US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669602" y="3635891"/>
            <a:ext cx="277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E</a:t>
            </a:r>
            <a:endParaRPr lang="en-US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2304887" y="3636064"/>
            <a:ext cx="277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F</a:t>
            </a:r>
            <a:endParaRPr lang="en-US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3569991" y="3635890"/>
            <a:ext cx="277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</a:t>
            </a:r>
            <a:endParaRPr lang="en-US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4869806" y="3645684"/>
            <a:ext cx="277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H</a:t>
            </a:r>
            <a:endParaRPr lang="en-US" b="1" dirty="0"/>
          </a:p>
        </p:txBody>
      </p:sp>
      <p:grpSp>
        <p:nvGrpSpPr>
          <p:cNvPr id="10" name="Group 9"/>
          <p:cNvGrpSpPr/>
          <p:nvPr/>
        </p:nvGrpSpPr>
        <p:grpSpPr>
          <a:xfrm>
            <a:off x="3412097" y="5281983"/>
            <a:ext cx="2276547" cy="1604833"/>
            <a:chOff x="3476280" y="4920238"/>
            <a:chExt cx="1369960" cy="1039724"/>
          </a:xfrm>
        </p:grpSpPr>
        <p:grpSp>
          <p:nvGrpSpPr>
            <p:cNvPr id="9" name="Group 8"/>
            <p:cNvGrpSpPr/>
            <p:nvPr/>
          </p:nvGrpSpPr>
          <p:grpSpPr>
            <a:xfrm>
              <a:off x="3476280" y="4920238"/>
              <a:ext cx="1233942" cy="980832"/>
              <a:chOff x="3476280" y="4920238"/>
              <a:chExt cx="1233942" cy="980832"/>
            </a:xfrm>
          </p:grpSpPr>
          <p:pic>
            <p:nvPicPr>
              <p:cNvPr id="67" name="Picture 66"/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99" r="7322" b="4693"/>
              <a:stretch/>
            </p:blipFill>
            <p:spPr>
              <a:xfrm>
                <a:off x="3498111" y="4928907"/>
                <a:ext cx="1212111" cy="972163"/>
              </a:xfrm>
              <a:prstGeom prst="rect">
                <a:avLst/>
              </a:prstGeom>
            </p:spPr>
          </p:pic>
          <p:sp>
            <p:nvSpPr>
              <p:cNvPr id="70" name="TextBox 69"/>
              <p:cNvSpPr txBox="1"/>
              <p:nvPr/>
            </p:nvSpPr>
            <p:spPr>
              <a:xfrm>
                <a:off x="3476280" y="4920238"/>
                <a:ext cx="180303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25" b="1" dirty="0" smtClean="0"/>
                  <a:t>J</a:t>
                </a:r>
                <a:endParaRPr lang="en-US" sz="825" b="1" dirty="0"/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4239847" y="5698352"/>
              <a:ext cx="6063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 smtClean="0"/>
                <a:t>Ventral</a:t>
              </a:r>
              <a:endParaRPr lang="en-US" sz="1100" dirty="0"/>
            </a:p>
          </p:txBody>
        </p:sp>
      </p:grpSp>
      <p:sp>
        <p:nvSpPr>
          <p:cNvPr id="56" name="Isosceles Triangle 55"/>
          <p:cNvSpPr/>
          <p:nvPr/>
        </p:nvSpPr>
        <p:spPr>
          <a:xfrm rot="12742740">
            <a:off x="2749900" y="6404352"/>
            <a:ext cx="45719" cy="8382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Isosceles Triangle 56"/>
          <p:cNvSpPr/>
          <p:nvPr/>
        </p:nvSpPr>
        <p:spPr>
          <a:xfrm rot="8531250">
            <a:off x="1793713" y="6395414"/>
            <a:ext cx="45719" cy="677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640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42</Words>
  <Application>Microsoft Office PowerPoint</Application>
  <PresentationFormat>On-screen Show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non Barry</dc:creator>
  <cp:lastModifiedBy>Shannon Barry</cp:lastModifiedBy>
  <cp:revision>7</cp:revision>
  <dcterms:created xsi:type="dcterms:W3CDTF">2017-07-14T17:38:47Z</dcterms:created>
  <dcterms:modified xsi:type="dcterms:W3CDTF">2017-07-14T17:41:48Z</dcterms:modified>
</cp:coreProperties>
</file>